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autoCompressPictures="0">
  <p:sldMasterIdLst>
    <p:sldMasterId id="2147483708" r:id="rId1"/>
  </p:sldMasterIdLst>
  <p:notesMasterIdLst>
    <p:notesMasterId r:id="rId3"/>
  </p:notesMasterIdLst>
  <p:sldIdLst>
    <p:sldId id="285" r:id="rId2"/>
  </p:sldIdLst>
  <p:sldSz cx="77724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1" userDrawn="1">
          <p15:clr>
            <a:srgbClr val="A4A3A4"/>
          </p15:clr>
        </p15:guide>
        <p15:guide id="2" pos="3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8DEB"/>
    <a:srgbClr val="E7D2F0"/>
    <a:srgbClr val="000005"/>
    <a:srgbClr val="FFFFC2"/>
    <a:srgbClr val="FFF380"/>
    <a:srgbClr val="00020C"/>
    <a:srgbClr val="00B700"/>
    <a:srgbClr val="B97E30"/>
    <a:srgbClr val="6BFF1C"/>
    <a:srgbClr val="FBAA4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259" autoAdjust="0"/>
  </p:normalViewPr>
  <p:slideViewPr>
    <p:cSldViewPr snapToGrid="0">
      <p:cViewPr varScale="1">
        <p:scale>
          <a:sx n="84" d="100"/>
          <a:sy n="84" d="100"/>
        </p:scale>
        <p:origin x="3320" y="184"/>
      </p:cViewPr>
      <p:guideLst>
        <p:guide orient="horz" pos="1521"/>
        <p:guide pos="36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7" tIns="46585" rIns="93167" bIns="46585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7" tIns="46585" rIns="93167" bIns="46585" rtlCol="0"/>
          <a:lstStyle>
            <a:lvl1pPr algn="r">
              <a:defRPr sz="1200"/>
            </a:lvl1pPr>
          </a:lstStyle>
          <a:p>
            <a:fld id="{8D442886-CECB-4E27-9019-4D41CC3A28AA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7" tIns="46585" rIns="93167" bIns="46585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67" tIns="46585" rIns="93167" bIns="4658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7" tIns="46585" rIns="93167" bIns="46585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7" tIns="46585" rIns="93167" bIns="46585" rtlCol="0" anchor="b"/>
          <a:lstStyle>
            <a:lvl1pPr algn="r">
              <a:defRPr sz="1200"/>
            </a:lvl1pPr>
          </a:lstStyle>
          <a:p>
            <a:fld id="{DC0C5D0C-17B8-4995-AB0E-7147D588304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07553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1pPr>
    <a:lvl2pPr marL="445595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2pPr>
    <a:lvl3pPr marL="891188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3pPr>
    <a:lvl4pPr marL="1336785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4pPr>
    <a:lvl5pPr marL="1782378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5pPr>
    <a:lvl6pPr marL="2227971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6pPr>
    <a:lvl7pPr marL="2673566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7pPr>
    <a:lvl8pPr marL="3119159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8pPr>
    <a:lvl9pPr marL="3564755" algn="l" defTabSz="891188" rtl="0" eaLnBrk="1" latinLnBrk="0" hangingPunct="1">
      <a:defRPr sz="117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3362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61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5151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908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8326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653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0287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8011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4295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4316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6846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9E03F-6C9C-43DC-8AA9-26D55DCA29D9}" type="datetimeFigureOut">
              <a:rPr lang="en-US" smtClean="0"/>
              <a:t>6/22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31B56-5541-4481-BA8F-8F4857C509A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0829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7341A79-67DC-C0FF-714A-8559F83C0D3B}"/>
              </a:ext>
            </a:extLst>
          </p:cNvPr>
          <p:cNvSpPr txBox="1"/>
          <p:nvPr/>
        </p:nvSpPr>
        <p:spPr>
          <a:xfrm>
            <a:off x="480873" y="7000847"/>
            <a:ext cx="681065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. Figure 2. Differential Expression of Senescence Markers in G1 and G2 Senescent Cells in IMR-90 cells.</a:t>
            </a:r>
            <a:r>
              <a:rPr lang="en-US" sz="1400" dirty="0"/>
              <a:t> Violin plots present the average expression levels of various senescence markers from replicated wells and experiments within the overall population, G1 or G2 states. A one-way ANOVA statistical test was performed where ****: p-value &lt; 0.0001. The expression levels of senescence markers significantly differ between cell cycle state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7B0BCC5-C947-76FD-D684-5C29232113A7}"/>
              </a:ext>
            </a:extLst>
          </p:cNvPr>
          <p:cNvSpPr txBox="1"/>
          <p:nvPr/>
        </p:nvSpPr>
        <p:spPr>
          <a:xfrm>
            <a:off x="133889" y="287786"/>
            <a:ext cx="16674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Suppl. Figure 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E714FED-CFAC-0842-8903-773CFF8C32A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0533"/>
          <a:stretch/>
        </p:blipFill>
        <p:spPr>
          <a:xfrm>
            <a:off x="279145" y="1381153"/>
            <a:ext cx="3467058" cy="468436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279947D-020F-2B5D-AE41-19463449B1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467"/>
          <a:stretch/>
        </p:blipFill>
        <p:spPr>
          <a:xfrm>
            <a:off x="3978937" y="1676400"/>
            <a:ext cx="3467058" cy="4785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A4788AF-946A-CF20-2F2D-065E99DBBC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3419" y="6019800"/>
            <a:ext cx="2042160" cy="3048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5DBA693A-A554-F1B6-B982-1512213746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3693" y="1320572"/>
            <a:ext cx="2737061" cy="49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6016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9040</TotalTime>
  <Words>76</Words>
  <Application>Microsoft Macintosh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pulation_Analysis_v01.2_2024-0318</dc:title>
  <dc:creator>Francesco Neri</dc:creator>
  <cp:lastModifiedBy>Birgit Schilling</cp:lastModifiedBy>
  <cp:revision>325</cp:revision>
  <cp:lastPrinted>2024-02-27T04:14:57Z</cp:lastPrinted>
  <dcterms:created xsi:type="dcterms:W3CDTF">2022-09-08T16:52:18Z</dcterms:created>
  <dcterms:modified xsi:type="dcterms:W3CDTF">2024-06-22T18:42:29Z</dcterms:modified>
</cp:coreProperties>
</file>